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907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9A205B-098E-4BEB-87A3-A25019DC4A7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07D9BA-1550-4467-B6EE-E149D2F0059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8DB51B-AD99-492B-88F2-221490D5898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64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428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00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64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428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CFD4FE-E73B-4F9C-ABCF-53B549E706C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0AB5B2-3D95-4DFF-8C6B-27F6AD50104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88B7D6-D14B-4FA3-AB54-2C50AC296F8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A78672-C963-4875-9C2D-4FD057CAAD1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0C193D-38C1-4186-8CB7-3E588F16F23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000" y="274320"/>
            <a:ext cx="8915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EFF561-1FAA-4E63-96D2-B4674DC1DE0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CC62E3-803C-4CFF-8DB1-0369948684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195556-4F01-49A0-BED4-32F6FE87C0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8ED06A-F5BB-4A8D-9C44-3CB07DD9E3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6245280"/>
            <a:ext cx="231120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6245280"/>
            <a:ext cx="313668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6245280"/>
            <a:ext cx="231156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D226942-E832-47FA-B071-377FDB553B0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8007480" y="538200"/>
            <a:ext cx="576000" cy="2232000"/>
          </a:xfrm>
          <a:prstGeom prst="rightArrow">
            <a:avLst>
              <a:gd name="adj1" fmla="val 22620"/>
              <a:gd name="adj2" fmla="val 56829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079640" y="538200"/>
            <a:ext cx="360360" cy="22510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168560" y="630360"/>
            <a:ext cx="179280" cy="177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168560" y="898560"/>
            <a:ext cx="179280" cy="179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168560" y="1168560"/>
            <a:ext cx="179280" cy="1774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168560" y="1438200"/>
            <a:ext cx="179280" cy="181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168560" y="1706400"/>
            <a:ext cx="179280" cy="1828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168560" y="1979640"/>
            <a:ext cx="179280" cy="177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168560" y="2247840"/>
            <a:ext cx="179280" cy="179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168560" y="2517840"/>
            <a:ext cx="179280" cy="179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619280" y="538200"/>
            <a:ext cx="360360" cy="22510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708200" y="630360"/>
            <a:ext cx="179280" cy="177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708200" y="898560"/>
            <a:ext cx="179280" cy="179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708200" y="1168560"/>
            <a:ext cx="179280" cy="1774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708200" y="1438200"/>
            <a:ext cx="179280" cy="181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708200" y="1706400"/>
            <a:ext cx="179280" cy="1828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1708200" y="1979640"/>
            <a:ext cx="179280" cy="177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708200" y="2247840"/>
            <a:ext cx="179280" cy="179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708200" y="2517840"/>
            <a:ext cx="179280" cy="179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2158920" y="538200"/>
            <a:ext cx="360360" cy="22510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2247840" y="630360"/>
            <a:ext cx="179280" cy="177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2247840" y="898560"/>
            <a:ext cx="179280" cy="179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2247840" y="1168560"/>
            <a:ext cx="179280" cy="1774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2247840" y="1438200"/>
            <a:ext cx="179280" cy="181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2247840" y="1706400"/>
            <a:ext cx="179280" cy="1828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2247840" y="1979640"/>
            <a:ext cx="179280" cy="177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2247840" y="2247840"/>
            <a:ext cx="179280" cy="179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2247840" y="2517840"/>
            <a:ext cx="179280" cy="179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3238560" y="538200"/>
            <a:ext cx="360360" cy="22510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3327480" y="630360"/>
            <a:ext cx="179280" cy="177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3327480" y="898560"/>
            <a:ext cx="179280" cy="179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3327480" y="1168560"/>
            <a:ext cx="179280" cy="1774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3327480" y="1438200"/>
            <a:ext cx="179280" cy="1810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3327480" y="1706400"/>
            <a:ext cx="179280" cy="1828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3327480" y="1979640"/>
            <a:ext cx="179280" cy="1778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3327480" y="2247840"/>
            <a:ext cx="179280" cy="179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3327480" y="2517840"/>
            <a:ext cx="179280" cy="179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3778200" y="538200"/>
            <a:ext cx="360360" cy="22510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3868560" y="630360"/>
            <a:ext cx="179640" cy="1778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3868560" y="898560"/>
            <a:ext cx="179640" cy="179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3868560" y="1168560"/>
            <a:ext cx="179640" cy="1774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3868560" y="1438200"/>
            <a:ext cx="179640" cy="1810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3868560" y="1706400"/>
            <a:ext cx="179640" cy="1828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3868560" y="1979640"/>
            <a:ext cx="179640" cy="1778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3868560" y="2247840"/>
            <a:ext cx="179640" cy="179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3868560" y="2517840"/>
            <a:ext cx="179640" cy="179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4317840" y="538200"/>
            <a:ext cx="360360" cy="22510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4408560" y="630360"/>
            <a:ext cx="179280" cy="1778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4408560" y="898560"/>
            <a:ext cx="179280" cy="179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4408560" y="1168560"/>
            <a:ext cx="179280" cy="1774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4408560" y="1438200"/>
            <a:ext cx="179280" cy="1810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4408560" y="1706400"/>
            <a:ext cx="179280" cy="1828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4408560" y="1979640"/>
            <a:ext cx="179280" cy="1778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4408560" y="2247840"/>
            <a:ext cx="179280" cy="179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4408560" y="2517840"/>
            <a:ext cx="179280" cy="179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4857840" y="538200"/>
            <a:ext cx="360360" cy="22510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4948200" y="630360"/>
            <a:ext cx="179280" cy="1778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4948200" y="898560"/>
            <a:ext cx="179280" cy="179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4948200" y="1168560"/>
            <a:ext cx="179280" cy="1774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4948200" y="1438200"/>
            <a:ext cx="179280" cy="181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4948200" y="1706400"/>
            <a:ext cx="179280" cy="1828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4948200" y="1979640"/>
            <a:ext cx="179280" cy="1778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4948200" y="2247840"/>
            <a:ext cx="179280" cy="179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4948200" y="2517840"/>
            <a:ext cx="179280" cy="179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5397480" y="538200"/>
            <a:ext cx="360360" cy="22510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5487840" y="630360"/>
            <a:ext cx="179640" cy="1778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5487840" y="898560"/>
            <a:ext cx="179640" cy="179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5487840" y="1168560"/>
            <a:ext cx="179640" cy="1774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5487840" y="1438200"/>
            <a:ext cx="179640" cy="1810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5487840" y="1706400"/>
            <a:ext cx="179640" cy="1828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5487840" y="1979640"/>
            <a:ext cx="179640" cy="1778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5487840" y="2247840"/>
            <a:ext cx="179640" cy="179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5487840" y="2517840"/>
            <a:ext cx="179640" cy="179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5937120" y="538200"/>
            <a:ext cx="360360" cy="22510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6027840" y="630360"/>
            <a:ext cx="179280" cy="1778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6027840" y="898560"/>
            <a:ext cx="179280" cy="179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6027840" y="1168560"/>
            <a:ext cx="179280" cy="1774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6027840" y="1438200"/>
            <a:ext cx="179280" cy="1810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6027840" y="1706400"/>
            <a:ext cx="179280" cy="1828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6027840" y="1979640"/>
            <a:ext cx="179280" cy="177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6027840" y="2247840"/>
            <a:ext cx="179280" cy="179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6027840" y="2517840"/>
            <a:ext cx="179280" cy="179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6477120" y="538200"/>
            <a:ext cx="360360" cy="22510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6567480" y="630360"/>
            <a:ext cx="179280" cy="1778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6567480" y="898560"/>
            <a:ext cx="179280" cy="179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6567480" y="1168560"/>
            <a:ext cx="179280" cy="1774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6567480" y="1438200"/>
            <a:ext cx="179280" cy="1810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6567480" y="1706400"/>
            <a:ext cx="179280" cy="1828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6567480" y="1979640"/>
            <a:ext cx="179280" cy="1778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6567480" y="2247840"/>
            <a:ext cx="179280" cy="179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6567480" y="2517840"/>
            <a:ext cx="179280" cy="179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7016760" y="549360"/>
            <a:ext cx="360360" cy="22492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7107120" y="630360"/>
            <a:ext cx="179640" cy="1778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7107120" y="898560"/>
            <a:ext cx="179640" cy="179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7107120" y="1168560"/>
            <a:ext cx="179640" cy="1774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7107120" y="1438200"/>
            <a:ext cx="179640" cy="1810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7107120" y="1706400"/>
            <a:ext cx="179640" cy="1828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7107120" y="1979640"/>
            <a:ext cx="179640" cy="1778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7107120" y="2247840"/>
            <a:ext cx="179640" cy="179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7107120" y="2517840"/>
            <a:ext cx="179640" cy="179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7556400" y="538200"/>
            <a:ext cx="360360" cy="22510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7647120" y="630360"/>
            <a:ext cx="179280" cy="177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7647120" y="898560"/>
            <a:ext cx="179280" cy="179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7647120" y="1168560"/>
            <a:ext cx="179280" cy="1774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7647120" y="1438200"/>
            <a:ext cx="179280" cy="1810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7647120" y="1706400"/>
            <a:ext cx="179280" cy="1828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7647120" y="1979640"/>
            <a:ext cx="179280" cy="1778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7647120" y="2247840"/>
            <a:ext cx="179280" cy="179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7647120" y="2517840"/>
            <a:ext cx="179280" cy="179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9175680" y="549360"/>
            <a:ext cx="360360" cy="22492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9266400" y="630360"/>
            <a:ext cx="179280" cy="1778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9266400" y="898560"/>
            <a:ext cx="179280" cy="179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9266400" y="1168560"/>
            <a:ext cx="179280" cy="1774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9266400" y="1438200"/>
            <a:ext cx="179280" cy="1810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9266400" y="1706400"/>
            <a:ext cx="179280" cy="1828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9266400" y="1979640"/>
            <a:ext cx="179280" cy="1778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9266400" y="2247840"/>
            <a:ext cx="179280" cy="179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9266400" y="2517840"/>
            <a:ext cx="179280" cy="179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0" y="87480"/>
            <a:ext cx="99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HIP #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8636040" y="538200"/>
            <a:ext cx="360360" cy="22510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8726400" y="630360"/>
            <a:ext cx="179640" cy="1778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8726400" y="898560"/>
            <a:ext cx="179640" cy="179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8726400" y="1168560"/>
            <a:ext cx="179640" cy="1774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8726400" y="1438200"/>
            <a:ext cx="179640" cy="1810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8726400" y="1706400"/>
            <a:ext cx="179640" cy="1828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8726400" y="1979640"/>
            <a:ext cx="179640" cy="177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8726400" y="2247840"/>
            <a:ext cx="179640" cy="179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8726400" y="2517840"/>
            <a:ext cx="179640" cy="179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2608200" y="538200"/>
            <a:ext cx="576360" cy="2232000"/>
          </a:xfrm>
          <a:prstGeom prst="rightArrow">
            <a:avLst>
              <a:gd name="adj1" fmla="val 22620"/>
              <a:gd name="adj2" fmla="val 56829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8042400" y="1376280"/>
            <a:ext cx="54000" cy="5400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8150400" y="1376280"/>
            <a:ext cx="53640" cy="5400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1079640" y="87480"/>
            <a:ext cx="35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1619280" y="87480"/>
            <a:ext cx="35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2158920" y="87480"/>
            <a:ext cx="35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3238560" y="87480"/>
            <a:ext cx="35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3778200" y="87480"/>
            <a:ext cx="35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4317840" y="87480"/>
            <a:ext cx="35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4857840" y="87480"/>
            <a:ext cx="35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5397480" y="87480"/>
            <a:ext cx="35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5937120" y="87480"/>
            <a:ext cx="35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6477120" y="87480"/>
            <a:ext cx="35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7016760" y="87480"/>
            <a:ext cx="35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7556400" y="87480"/>
            <a:ext cx="35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8636040" y="87480"/>
            <a:ext cx="35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9175680" y="87480"/>
            <a:ext cx="35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 rot="16200000">
            <a:off x="213840" y="1322280"/>
            <a:ext cx="362880" cy="822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 anchorCtr="1" vert="eaVer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PO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719280" y="629640"/>
            <a:ext cx="35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 anchorCtr="1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719280" y="897840"/>
            <a:ext cx="35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 anchorCtr="1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719280" y="1167480"/>
            <a:ext cx="35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 anchorCtr="1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719280" y="1437480"/>
            <a:ext cx="35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 anchorCtr="1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719280" y="1705680"/>
            <a:ext cx="35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 anchorCtr="1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719280" y="1978920"/>
            <a:ext cx="35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 anchorCtr="1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719280" y="2247120"/>
            <a:ext cx="35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 anchorCtr="1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719280" y="2517120"/>
            <a:ext cx="35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 anchorCtr="1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8096400" y="87480"/>
            <a:ext cx="35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.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0" y="5950080"/>
            <a:ext cx="7273800" cy="127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Figure S1 Standard protocol of QC spot application in a SELDI study. The first three chips contain only QC spots then on the fourth and subsequent chips (the sample chips) one spot is a QC spot. The spot which contains the QC spot on the sample chips moves through the spot locations throughout the study by one position, e.g. on chip 4, spot A on chip 5, spot B and so on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5-28T12:36:42Z</dcterms:created>
  <dc:creator>David Cairns</dc:creator>
  <dc:description/>
  <dc:language>en-US</dc:language>
  <cp:lastModifiedBy>David Cairns</cp:lastModifiedBy>
  <dcterms:modified xsi:type="dcterms:W3CDTF">2008-09-30T22:40:02Z</dcterms:modified>
  <cp:revision>19</cp:revision>
  <dc:subject/>
  <dc:title>Slide 1</dc:title>
</cp:coreProperties>
</file>